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3" d="100"/>
          <a:sy n="73" d="100"/>
        </p:scale>
        <p:origin x="67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4EFCE1-9F55-4334-9FAB-872ED94D5772}" type="datetimeFigureOut">
              <a:rPr lang="en-US" smtClean="0"/>
              <a:t>7/14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4A88C8-1A0A-4ED1-A77B-D178B86907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12830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7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48225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7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1668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7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1421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7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0848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7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76906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7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56955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7/14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890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7/1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6822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7/14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607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7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7637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7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9336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4F0553-8230-45C5-B503-7ED6E25E4620}" type="datetimeFigureOut">
              <a:rPr lang="en-US" smtClean="0"/>
              <a:t>7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33219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2.emf"/><Relationship Id="rId7" Type="http://schemas.openxmlformats.org/officeDocument/2006/relationships/image" Target="../media/image5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Picture 5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07178" y="1553229"/>
            <a:ext cx="1796720" cy="1737360"/>
          </a:xfrm>
          <a:prstGeom prst="rect">
            <a:avLst/>
          </a:prstGeom>
        </p:spPr>
      </p:pic>
      <p:pic>
        <p:nvPicPr>
          <p:cNvPr id="54" name="Picture 5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862418" y="3345770"/>
            <a:ext cx="1796720" cy="1737360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colorTemperature colorTemp="5500"/>
                    </a14:imgEffect>
                    <a14:imgEffect>
                      <a14:saturation sat="110000"/>
                    </a14:imgEffect>
                    <a14:imgEffect>
                      <a14:brightnessContrast bright="1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0415" y="1707805"/>
            <a:ext cx="4260456" cy="32004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838391" y="1553603"/>
            <a:ext cx="1721333" cy="173736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620605" y="1545984"/>
            <a:ext cx="1796720" cy="173736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620605" y="3340458"/>
            <a:ext cx="1796720" cy="173736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999227" y="4899199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Sham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950893" y="4899199"/>
            <a:ext cx="8851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tMCAO+veh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988598" y="4899199"/>
            <a:ext cx="10005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tMCAO+shNC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029649" y="4899199"/>
            <a:ext cx="11031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tMCAO+shLPA</a:t>
            </a:r>
            <a:r>
              <a:rPr lang="en-US" altLang="ko-KR" sz="1000" baseline="-25000" dirty="0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1</a:t>
            </a:r>
            <a:endParaRPr lang="ko-KR" altLang="en-US" sz="1000" baseline="-250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10" name="TextBox 20"/>
          <p:cNvSpPr txBox="1"/>
          <p:nvPr/>
        </p:nvSpPr>
        <p:spPr>
          <a:xfrm>
            <a:off x="6252530" y="3534437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smtClean="0">
                <a:latin typeface="+mj-lt"/>
                <a:cs typeface="Arial" panose="020B0604020202020204" pitchFamily="34" charset="0"/>
              </a:rPr>
              <a:t>***</a:t>
            </a:r>
            <a:endParaRPr lang="en-US" sz="16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594706" y="3462566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smtClean="0">
                <a:latin typeface="+mj-lt"/>
                <a:cs typeface="Arial" panose="020B0604020202020204" pitchFamily="34" charset="0"/>
              </a:rPr>
              <a:t>***</a:t>
            </a:r>
            <a:endParaRPr lang="en-US" sz="16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12" name="TextBox 20"/>
          <p:cNvSpPr txBox="1"/>
          <p:nvPr/>
        </p:nvSpPr>
        <p:spPr>
          <a:xfrm>
            <a:off x="6310039" y="1875303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smtClean="0">
                <a:latin typeface="+mj-lt"/>
                <a:cs typeface="Arial" panose="020B0604020202020204" pitchFamily="34" charset="0"/>
              </a:rPr>
              <a:t>**</a:t>
            </a:r>
            <a:endParaRPr lang="en-US" sz="16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590069" y="1632664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smtClean="0">
                <a:latin typeface="+mj-lt"/>
                <a:cs typeface="Arial" panose="020B0604020202020204" pitchFamily="34" charset="0"/>
              </a:rPr>
              <a:t>***</a:t>
            </a:r>
            <a:endParaRPr lang="en-US" sz="16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14" name="TextBox 20"/>
          <p:cNvSpPr txBox="1"/>
          <p:nvPr/>
        </p:nvSpPr>
        <p:spPr>
          <a:xfrm>
            <a:off x="7055719" y="2022182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 smtClean="0">
                <a:latin typeface="+mj-lt"/>
                <a:cs typeface="Arial" panose="020B0604020202020204" pitchFamily="34" charset="0"/>
              </a:rPr>
              <a:t>#</a:t>
            </a:r>
            <a:endParaRPr lang="en-US" sz="12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870450" y="4975386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552681" y="5211162"/>
            <a:ext cx="6799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MCAO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6558416" y="4969488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Straight Connector 17"/>
          <p:cNvCxnSpPr/>
          <p:nvPr/>
        </p:nvCxnSpPr>
        <p:spPr>
          <a:xfrm>
            <a:off x="6349926" y="5209080"/>
            <a:ext cx="100584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6915330" y="4969488"/>
            <a:ext cx="63190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hLPA</a:t>
            </a:r>
            <a:r>
              <a:rPr lang="en-US" altLang="ko-KR" sz="10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6298071" y="4975386"/>
            <a:ext cx="3898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524268" y="140061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066394" y="140061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9507891" y="146099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 rot="16200000">
            <a:off x="4668200" y="3203054"/>
            <a:ext cx="14542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No. of 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Iba1</a:t>
            </a:r>
            <a:r>
              <a:rPr lang="en-US" altLang="ko-KR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cells/mm</a:t>
            </a:r>
            <a:r>
              <a:rPr lang="en-US" altLang="ko-K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 rot="16200000">
            <a:off x="5126812" y="2352924"/>
            <a:ext cx="9108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riischemic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6200000">
            <a:off x="5104431" y="4104654"/>
            <a:ext cx="9733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Ischemic core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541382" y="2072456"/>
            <a:ext cx="2824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885296" y="1763460"/>
            <a:ext cx="1602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 rot="16200000">
            <a:off x="203606" y="4251306"/>
            <a:ext cx="9733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Ischemic core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 rot="16200000">
            <a:off x="234864" y="3199092"/>
            <a:ext cx="9108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riischemic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720322" y="2026463"/>
            <a:ext cx="2824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2142268" y="1777455"/>
            <a:ext cx="1602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726737" y="2092605"/>
            <a:ext cx="2824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005762" y="1792233"/>
            <a:ext cx="1602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833017" y="1904230"/>
            <a:ext cx="2824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4219987" y="1806999"/>
            <a:ext cx="1602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9990949" y="3169586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10673180" y="3405362"/>
            <a:ext cx="6799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MCAO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10678915" y="3163688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Straight Connector 39"/>
          <p:cNvCxnSpPr/>
          <p:nvPr/>
        </p:nvCxnSpPr>
        <p:spPr>
          <a:xfrm>
            <a:off x="10470425" y="3403280"/>
            <a:ext cx="100584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11035829" y="3163688"/>
            <a:ext cx="63190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hLPA</a:t>
            </a:r>
            <a:r>
              <a:rPr lang="en-US" altLang="ko-KR" sz="10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10418570" y="3169586"/>
            <a:ext cx="3898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10393151" y="1742378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smtClean="0">
                <a:latin typeface="+mj-lt"/>
                <a:cs typeface="Arial" panose="020B0604020202020204" pitchFamily="34" charset="0"/>
              </a:rPr>
              <a:t>***</a:t>
            </a:r>
            <a:endParaRPr lang="en-US" sz="16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10709445" y="1791266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smtClean="0">
                <a:latin typeface="+mj-lt"/>
                <a:cs typeface="Arial" panose="020B0604020202020204" pitchFamily="34" charset="0"/>
              </a:rPr>
              <a:t>***</a:t>
            </a:r>
            <a:endParaRPr lang="en-US" sz="16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45" name="TextBox 20"/>
          <p:cNvSpPr txBox="1"/>
          <p:nvPr/>
        </p:nvSpPr>
        <p:spPr>
          <a:xfrm>
            <a:off x="11108265" y="2701375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>
                <a:latin typeface="+mj-lt"/>
                <a:cs typeface="Arial" panose="020B0604020202020204" pitchFamily="34" charset="0"/>
              </a:rPr>
              <a:t>###</a:t>
            </a:r>
          </a:p>
        </p:txBody>
      </p:sp>
      <p:sp>
        <p:nvSpPr>
          <p:cNvPr id="46" name="Isosceles Triangle 45"/>
          <p:cNvSpPr/>
          <p:nvPr/>
        </p:nvSpPr>
        <p:spPr>
          <a:xfrm>
            <a:off x="2318274" y="4603747"/>
            <a:ext cx="57528" cy="58826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Isosceles Triangle 46"/>
          <p:cNvSpPr/>
          <p:nvPr/>
        </p:nvSpPr>
        <p:spPr>
          <a:xfrm>
            <a:off x="2135908" y="4751473"/>
            <a:ext cx="57528" cy="58826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Isosceles Triangle 47"/>
          <p:cNvSpPr/>
          <p:nvPr/>
        </p:nvSpPr>
        <p:spPr>
          <a:xfrm>
            <a:off x="3736116" y="4240436"/>
            <a:ext cx="57528" cy="58826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Isosceles Triangle 48"/>
          <p:cNvSpPr/>
          <p:nvPr/>
        </p:nvSpPr>
        <p:spPr>
          <a:xfrm>
            <a:off x="3217956" y="4729676"/>
            <a:ext cx="57528" cy="58826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Isosceles Triangle 49"/>
          <p:cNvSpPr/>
          <p:nvPr/>
        </p:nvSpPr>
        <p:spPr>
          <a:xfrm>
            <a:off x="4422090" y="4014516"/>
            <a:ext cx="57528" cy="58826"/>
          </a:xfrm>
          <a:prstGeom prst="triangle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Isosceles Triangle 50"/>
          <p:cNvSpPr/>
          <p:nvPr/>
        </p:nvSpPr>
        <p:spPr>
          <a:xfrm>
            <a:off x="4734918" y="4487763"/>
            <a:ext cx="57528" cy="58826"/>
          </a:xfrm>
          <a:prstGeom prst="triangle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TextBox 51"/>
          <p:cNvSpPr txBox="1"/>
          <p:nvPr/>
        </p:nvSpPr>
        <p:spPr>
          <a:xfrm rot="16200000">
            <a:off x="8954740" y="2325108"/>
            <a:ext cx="16770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atio 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amoeboid/ramified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 rot="16200000">
            <a:off x="7025513" y="3264577"/>
            <a:ext cx="11464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oma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size (µm</a:t>
            </a:r>
            <a:r>
              <a:rPr lang="en-US" altLang="ko-KR" sz="10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 rot="16200000">
            <a:off x="7325388" y="2355961"/>
            <a:ext cx="9108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eriischemic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 rot="16200000">
            <a:off x="7294130" y="4086185"/>
            <a:ext cx="9733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Ischemic core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7305295" y="1466753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20"/>
          <p:cNvSpPr txBox="1"/>
          <p:nvPr/>
        </p:nvSpPr>
        <p:spPr>
          <a:xfrm>
            <a:off x="8423494" y="1745901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smtClean="0">
                <a:latin typeface="+mj-lt"/>
                <a:cs typeface="Arial" panose="020B0604020202020204" pitchFamily="34" charset="0"/>
              </a:rPr>
              <a:t>***</a:t>
            </a:r>
            <a:endParaRPr lang="en-US" sz="16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8782922" y="1846054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smtClean="0">
                <a:latin typeface="+mj-lt"/>
                <a:cs typeface="Arial" panose="020B0604020202020204" pitchFamily="34" charset="0"/>
              </a:rPr>
              <a:t>***</a:t>
            </a:r>
            <a:endParaRPr lang="en-US" sz="16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66" name="TextBox 20"/>
          <p:cNvSpPr txBox="1"/>
          <p:nvPr/>
        </p:nvSpPr>
        <p:spPr>
          <a:xfrm>
            <a:off x="9190327" y="223268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 smtClean="0">
                <a:latin typeface="+mj-lt"/>
                <a:cs typeface="Arial" panose="020B0604020202020204" pitchFamily="34" charset="0"/>
              </a:rPr>
              <a:t>##</a:t>
            </a:r>
            <a:endParaRPr lang="en-US" sz="12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67" name="TextBox 20"/>
          <p:cNvSpPr txBox="1"/>
          <p:nvPr/>
        </p:nvSpPr>
        <p:spPr>
          <a:xfrm>
            <a:off x="8489634" y="3727083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smtClean="0">
                <a:latin typeface="+mj-lt"/>
                <a:cs typeface="Arial" panose="020B0604020202020204" pitchFamily="34" charset="0"/>
              </a:rPr>
              <a:t>***</a:t>
            </a:r>
            <a:endParaRPr lang="en-US" sz="16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8831810" y="3603451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smtClean="0">
                <a:latin typeface="+mj-lt"/>
                <a:cs typeface="Arial" panose="020B0604020202020204" pitchFamily="34" charset="0"/>
              </a:rPr>
              <a:t>***</a:t>
            </a:r>
            <a:endParaRPr lang="en-US" sz="16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69" name="TextBox 20"/>
          <p:cNvSpPr txBox="1"/>
          <p:nvPr/>
        </p:nvSpPr>
        <p:spPr>
          <a:xfrm>
            <a:off x="9200274" y="4083488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>
                <a:latin typeface="+mj-lt"/>
                <a:cs typeface="Arial" panose="020B0604020202020204" pitchFamily="34" charset="0"/>
              </a:rPr>
              <a:t>###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8101799" y="4972516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8784030" y="5208292"/>
            <a:ext cx="6799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MCAO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8789765" y="4966618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3" name="Straight Connector 72"/>
          <p:cNvCxnSpPr/>
          <p:nvPr/>
        </p:nvCxnSpPr>
        <p:spPr>
          <a:xfrm>
            <a:off x="8581275" y="5206210"/>
            <a:ext cx="100584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/>
          <p:cNvSpPr txBox="1"/>
          <p:nvPr/>
        </p:nvSpPr>
        <p:spPr>
          <a:xfrm>
            <a:off x="9146679" y="4966618"/>
            <a:ext cx="63190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hLPA</a:t>
            </a:r>
            <a:r>
              <a:rPr lang="en-US" altLang="ko-KR" sz="10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8529420" y="4972516"/>
            <a:ext cx="3898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39873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33</TotalTime>
  <Words>72</Words>
  <Application>Microsoft Office PowerPoint</Application>
  <PresentationFormat>Widescreen</PresentationFormat>
  <Paragraphs>5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 Unicode MS</vt:lpstr>
      <vt:lpstr>맑은 고딕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사용자</dc:creator>
  <cp:lastModifiedBy>Windows 사용자</cp:lastModifiedBy>
  <cp:revision>90</cp:revision>
  <dcterms:created xsi:type="dcterms:W3CDTF">2019-06-25T05:43:47Z</dcterms:created>
  <dcterms:modified xsi:type="dcterms:W3CDTF">2019-07-14T14:07:09Z</dcterms:modified>
</cp:coreProperties>
</file>